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4" r:id="rId2"/>
    <p:sldId id="266" r:id="rId3"/>
    <p:sldId id="276" r:id="rId4"/>
    <p:sldId id="275" r:id="rId5"/>
    <p:sldId id="273" r:id="rId6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4953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981"/>
    <p:restoredTop sz="96327"/>
  </p:normalViewPr>
  <p:slideViewPr>
    <p:cSldViewPr snapToGrid="0">
      <p:cViewPr varScale="1">
        <p:scale>
          <a:sx n="93" d="100"/>
          <a:sy n="93" d="100"/>
        </p:scale>
        <p:origin x="341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64D7A-01A5-6D44-BBBC-8589A7EA705A}" type="datetimeFigureOut">
              <a:rPr lang="en-US" smtClean="0"/>
              <a:t>7/2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D7D46-3FDF-8E46-8CCC-A0BB8E3167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016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64D7A-01A5-6D44-BBBC-8589A7EA705A}" type="datetimeFigureOut">
              <a:rPr lang="en-US" smtClean="0"/>
              <a:t>7/2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D7D46-3FDF-8E46-8CCC-A0BB8E3167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5555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64D7A-01A5-6D44-BBBC-8589A7EA705A}" type="datetimeFigureOut">
              <a:rPr lang="en-US" smtClean="0"/>
              <a:t>7/2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D7D46-3FDF-8E46-8CCC-A0BB8E3167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2516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64D7A-01A5-6D44-BBBC-8589A7EA705A}" type="datetimeFigureOut">
              <a:rPr lang="en-US" smtClean="0"/>
              <a:t>7/2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D7D46-3FDF-8E46-8CCC-A0BB8E3167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5740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64D7A-01A5-6D44-BBBC-8589A7EA705A}" type="datetimeFigureOut">
              <a:rPr lang="en-US" smtClean="0"/>
              <a:t>7/2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D7D46-3FDF-8E46-8CCC-A0BB8E3167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12052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64D7A-01A5-6D44-BBBC-8589A7EA705A}" type="datetimeFigureOut">
              <a:rPr lang="en-US" smtClean="0"/>
              <a:t>7/25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D7D46-3FDF-8E46-8CCC-A0BB8E3167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03245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64D7A-01A5-6D44-BBBC-8589A7EA705A}" type="datetimeFigureOut">
              <a:rPr lang="en-US" smtClean="0"/>
              <a:t>7/25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D7D46-3FDF-8E46-8CCC-A0BB8E3167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76687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64D7A-01A5-6D44-BBBC-8589A7EA705A}" type="datetimeFigureOut">
              <a:rPr lang="en-US" smtClean="0"/>
              <a:t>7/25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D7D46-3FDF-8E46-8CCC-A0BB8E3167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6239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64D7A-01A5-6D44-BBBC-8589A7EA705A}" type="datetimeFigureOut">
              <a:rPr lang="en-US" smtClean="0"/>
              <a:t>7/25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D7D46-3FDF-8E46-8CCC-A0BB8E3167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92528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64D7A-01A5-6D44-BBBC-8589A7EA705A}" type="datetimeFigureOut">
              <a:rPr lang="en-US" smtClean="0"/>
              <a:t>7/25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D7D46-3FDF-8E46-8CCC-A0BB8E3167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0174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64D7A-01A5-6D44-BBBC-8589A7EA705A}" type="datetimeFigureOut">
              <a:rPr lang="en-US" smtClean="0"/>
              <a:t>7/25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D7D46-3FDF-8E46-8CCC-A0BB8E3167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6604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B64D7A-01A5-6D44-BBBC-8589A7EA705A}" type="datetimeFigureOut">
              <a:rPr lang="en-US" smtClean="0"/>
              <a:t>7/2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9D7D46-3FDF-8E46-8CCC-A0BB8E3167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47266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emf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3DC502D-A94F-A40A-B6EF-33872158B0CE}"/>
              </a:ext>
            </a:extLst>
          </p:cNvPr>
          <p:cNvSpPr txBox="1"/>
          <p:nvPr/>
        </p:nvSpPr>
        <p:spPr>
          <a:xfrm>
            <a:off x="609600" y="1211374"/>
            <a:ext cx="5638800" cy="37856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Development of a V5-tag-directed nanobody and its implementation as an intracellular biosensor of GPCR signalling</a:t>
            </a:r>
          </a:p>
          <a:p>
            <a:pPr algn="ctr"/>
            <a:r>
              <a:rPr lang="en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 </a:t>
            </a:r>
            <a:endParaRPr lang="en-CA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algn="just"/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Manel Zeghal</a:t>
            </a:r>
            <a:r>
              <a:rPr lang="fr-CA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1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*, Kevin Matte</a:t>
            </a:r>
            <a:r>
              <a:rPr lang="fr-CA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1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*, Angelica Venes</a:t>
            </a:r>
            <a:r>
              <a:rPr lang="fr-CA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1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, </a:t>
            </a:r>
            <a:r>
              <a:rPr lang="fr-CA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Shivani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Patel</a:t>
            </a:r>
            <a:r>
              <a:rPr lang="fr-CA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1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, Geneviève Laroche</a:t>
            </a:r>
            <a:r>
              <a:rPr lang="fr-CA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1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, Sabina Sarvan</a:t>
            </a:r>
            <a:r>
              <a:rPr lang="fr-CA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1,2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, Monika Joshi</a:t>
            </a:r>
            <a:r>
              <a:rPr lang="fr-CA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1,2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, Jean-Christophe Rain</a:t>
            </a:r>
            <a:r>
              <a:rPr lang="fr-CA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3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, Jean-François Couture</a:t>
            </a:r>
            <a:r>
              <a:rPr lang="fr-CA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1,2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, Patrick M. Giguère</a:t>
            </a:r>
            <a:r>
              <a:rPr lang="fr-CA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1,4✉️</a:t>
            </a:r>
          </a:p>
          <a:p>
            <a:pPr algn="just"/>
            <a:endParaRPr lang="fr-CA" sz="12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  <a:p>
            <a:pPr algn="just"/>
            <a:r>
              <a:rPr lang="fr-CA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From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the </a:t>
            </a:r>
            <a:r>
              <a:rPr lang="fr-CA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1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Department of </a:t>
            </a:r>
            <a:r>
              <a:rPr lang="fr-CA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Biochemistry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, </a:t>
            </a:r>
            <a:r>
              <a:rPr lang="fr-CA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Microbiology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and </a:t>
            </a:r>
            <a:r>
              <a:rPr lang="fr-CA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Immunology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, </a:t>
            </a:r>
            <a:r>
              <a:rPr lang="fr-CA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Faculty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of </a:t>
            </a:r>
            <a:r>
              <a:rPr lang="fr-CA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Medicine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, </a:t>
            </a:r>
            <a:r>
              <a:rPr lang="fr-CA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University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of Ottawa, Ottawa, ON, K1H 8M5, Canada;  </a:t>
            </a:r>
            <a:r>
              <a:rPr lang="fr-CA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2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Ottawa Institute of </a:t>
            </a:r>
            <a:r>
              <a:rPr lang="fr-CA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Systems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fr-CA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Biology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, </a:t>
            </a:r>
            <a:r>
              <a:rPr lang="fr-CA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University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of Ottawa, Ottawa, ON K1H 8M5, Canada; </a:t>
            </a:r>
            <a:r>
              <a:rPr lang="fr-CA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3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Hybrigenics Services, 91000 Évry-Courcouronnes, France; </a:t>
            </a:r>
            <a:r>
              <a:rPr lang="fr-CA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4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Brain and </a:t>
            </a:r>
            <a:r>
              <a:rPr lang="fr-CA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Mind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fr-CA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Research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Institute, </a:t>
            </a:r>
            <a:r>
              <a:rPr lang="fr-CA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University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of Ottawa, Ottawa, ON, K1H 8M5, Canada</a:t>
            </a:r>
          </a:p>
          <a:p>
            <a:pPr algn="just"/>
            <a:endParaRPr lang="fr-CA" sz="12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  <a:p>
            <a:pPr algn="just"/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* </a:t>
            </a:r>
            <a:r>
              <a:rPr lang="fr-CA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Contributed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fr-CA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equally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to the </a:t>
            </a:r>
            <a:r>
              <a:rPr lang="fr-CA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work</a:t>
            </a:r>
            <a:endParaRPr lang="fr-CA" sz="12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  <a:p>
            <a:pPr algn="just"/>
            <a:endParaRPr lang="fr-CA" sz="12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  <a:p>
            <a:pPr algn="just"/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✉️</a:t>
            </a:r>
            <a:r>
              <a:rPr lang="fr-CA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Correspondence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and </a:t>
            </a:r>
            <a:r>
              <a:rPr lang="fr-CA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requests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for </a:t>
            </a:r>
            <a:r>
              <a:rPr lang="fr-CA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materials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fr-CA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should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fr-CA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be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fr-CA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addressed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to Patrick M. Giguère </a:t>
            </a:r>
          </a:p>
          <a:p>
            <a:pPr algn="just"/>
            <a:endParaRPr lang="fr-CA" sz="12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  <a:p>
            <a:pPr algn="just"/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(Email : </a:t>
            </a:r>
            <a:r>
              <a:rPr lang="fr-CA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patrick.giguere@uottawa.ca</a:t>
            </a:r>
            <a:r>
              <a:rPr lang="fr-CA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).</a:t>
            </a:r>
          </a:p>
          <a:p>
            <a:pPr algn="just"/>
            <a:endParaRPr lang="fr-CA" sz="12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AFAE83A-121C-9300-0213-33E9896CEA77}"/>
              </a:ext>
            </a:extLst>
          </p:cNvPr>
          <p:cNvSpPr txBox="1"/>
          <p:nvPr/>
        </p:nvSpPr>
        <p:spPr>
          <a:xfrm>
            <a:off x="1714500" y="620368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800" b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SUPPORTING INFORMATION</a:t>
            </a:r>
            <a:endParaRPr lang="en-CA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209038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C951ECF-F040-5955-4C5C-97ACAD2FE820}"/>
              </a:ext>
            </a:extLst>
          </p:cNvPr>
          <p:cNvSpPr txBox="1"/>
          <p:nvPr/>
        </p:nvSpPr>
        <p:spPr>
          <a:xfrm>
            <a:off x="2930597" y="8175171"/>
            <a:ext cx="1231427" cy="3274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528" dirty="0">
                <a:latin typeface="Arial" panose="020B0604020202020204" pitchFamily="34" charset="0"/>
                <a:cs typeface="Arial" panose="020B0604020202020204" pitchFamily="34" charset="0"/>
              </a:rPr>
              <a:t>Suppl. Fig.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9C6BE86-C269-DDAB-EDB5-1936E7A27071}"/>
              </a:ext>
            </a:extLst>
          </p:cNvPr>
          <p:cNvSpPr txBox="1"/>
          <p:nvPr/>
        </p:nvSpPr>
        <p:spPr>
          <a:xfrm>
            <a:off x="594642" y="5128592"/>
            <a:ext cx="5656205" cy="19688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100" b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Supplementary Figure 1: Structure of the NbA1 bound to the V5 peptide. </a:t>
            </a:r>
            <a:endParaRPr lang="en-CA" sz="11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algn="just"/>
            <a:r>
              <a:rPr lang="en-CA" sz="11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A, Overlay of the NbA1:V5 structure with the </a:t>
            </a:r>
            <a:r>
              <a:rPr lang="en-CA" sz="11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NbALFA:ALFA</a:t>
            </a:r>
            <a:r>
              <a:rPr lang="en-CA" sz="11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(PDB: 6I2G) structure. The </a:t>
            </a:r>
            <a:r>
              <a:rPr lang="en-CA" sz="11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NbALFA</a:t>
            </a:r>
            <a:r>
              <a:rPr lang="en-CA" sz="11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structure was omitted for simplicity and to present the binding pose of the ALFA-tag, which is at 90 degrees compared with the V5-tag. Using </a:t>
            </a:r>
            <a:r>
              <a:rPr lang="en-CA" sz="1100" i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in silico</a:t>
            </a:r>
            <a:r>
              <a:rPr lang="en-CA" sz="11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maturation and functional studies assessment, the mutations ΔAsp</a:t>
            </a:r>
            <a:r>
              <a:rPr lang="en-CA" sz="11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59</a:t>
            </a:r>
            <a:r>
              <a:rPr lang="en-CA" sz="11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, Ser</a:t>
            </a:r>
            <a:r>
              <a:rPr lang="en-CA" sz="11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60</a:t>
            </a:r>
            <a:r>
              <a:rPr lang="en-CA" sz="11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Lys were discovered to substantially improve the behavior of the nanobody.</a:t>
            </a:r>
            <a:r>
              <a:rPr lang="en-CA" sz="1100" b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CA" sz="11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B, Close-up view of the Asp</a:t>
            </a:r>
            <a:r>
              <a:rPr lang="en-CA" sz="11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59</a:t>
            </a:r>
            <a:r>
              <a:rPr lang="en-CA" sz="11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and Ser</a:t>
            </a:r>
            <a:r>
              <a:rPr lang="en-CA" sz="11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60</a:t>
            </a:r>
            <a:r>
              <a:rPr lang="en-CA" sz="11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of the CDR2 loop that are juxtaposed to the disordered tripeptide RQG. The Ser</a:t>
            </a:r>
            <a:r>
              <a:rPr lang="en-CA" sz="11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60</a:t>
            </a:r>
            <a:r>
              <a:rPr lang="en-CA" sz="11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is not involved in any interaction and the distance with the closest residues is shown with a dash line. C, It is hypothesized that mutations ΔAsp59 and Ser</a:t>
            </a:r>
            <a:r>
              <a:rPr lang="en-CA" sz="11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60</a:t>
            </a:r>
            <a:r>
              <a:rPr lang="en-CA" sz="11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Lys could favorize new intramolecular polar interactions within the CDR2 loop which might stabilize it by reducing entropy.</a:t>
            </a:r>
            <a:endParaRPr lang="en-CA" sz="11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8CA03EC2-F675-A9AE-E357-4B41D31143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4642" y="1830020"/>
            <a:ext cx="5561734" cy="28385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171239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1">
            <a:extLst>
              <a:ext uri="{FF2B5EF4-FFF2-40B4-BE49-F238E27FC236}">
                <a16:creationId xmlns:a16="http://schemas.microsoft.com/office/drawing/2014/main" id="{EDD63A94-7F6D-D965-F43C-D2B005941A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3738" y="815526"/>
            <a:ext cx="1690815" cy="1710475"/>
          </a:xfrm>
          <a:prstGeom prst="rect">
            <a:avLst/>
          </a:prstGeom>
        </p:spPr>
      </p:pic>
      <p:pic>
        <p:nvPicPr>
          <p:cNvPr id="6" name="Image 2">
            <a:extLst>
              <a:ext uri="{FF2B5EF4-FFF2-40B4-BE49-F238E27FC236}">
                <a16:creationId xmlns:a16="http://schemas.microsoft.com/office/drawing/2014/main" id="{823B205E-E475-C42D-E01E-E2A96A86B58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24553" y="815526"/>
            <a:ext cx="1690815" cy="1710475"/>
          </a:xfrm>
          <a:prstGeom prst="rect">
            <a:avLst/>
          </a:prstGeom>
        </p:spPr>
      </p:pic>
      <p:pic>
        <p:nvPicPr>
          <p:cNvPr id="7" name="Image 3">
            <a:extLst>
              <a:ext uri="{FF2B5EF4-FFF2-40B4-BE49-F238E27FC236}">
                <a16:creationId xmlns:a16="http://schemas.microsoft.com/office/drawing/2014/main" id="{4DDDDC6E-17AC-A836-9417-F9957808627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15368" y="815526"/>
            <a:ext cx="1690815" cy="1710475"/>
          </a:xfrm>
          <a:prstGeom prst="rect">
            <a:avLst/>
          </a:prstGeom>
        </p:spPr>
      </p:pic>
      <p:sp>
        <p:nvSpPr>
          <p:cNvPr id="8" name="ZoneTexte 4">
            <a:extLst>
              <a:ext uri="{FF2B5EF4-FFF2-40B4-BE49-F238E27FC236}">
                <a16:creationId xmlns:a16="http://schemas.microsoft.com/office/drawing/2014/main" id="{D57FFCD1-5B44-94A4-D07F-AA847D905A67}"/>
              </a:ext>
            </a:extLst>
          </p:cNvPr>
          <p:cNvSpPr txBox="1"/>
          <p:nvPr/>
        </p:nvSpPr>
        <p:spPr>
          <a:xfrm>
            <a:off x="904465" y="667258"/>
            <a:ext cx="1405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ZoneTexte 5">
            <a:extLst>
              <a:ext uri="{FF2B5EF4-FFF2-40B4-BE49-F238E27FC236}">
                <a16:creationId xmlns:a16="http://schemas.microsoft.com/office/drawing/2014/main" id="{9B9C292C-068E-3766-E667-4F70BF3218C7}"/>
              </a:ext>
            </a:extLst>
          </p:cNvPr>
          <p:cNvSpPr txBox="1"/>
          <p:nvPr/>
        </p:nvSpPr>
        <p:spPr>
          <a:xfrm>
            <a:off x="899813" y="2517379"/>
            <a:ext cx="1369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1" name="ZoneTexte 7">
            <a:extLst>
              <a:ext uri="{FF2B5EF4-FFF2-40B4-BE49-F238E27FC236}">
                <a16:creationId xmlns:a16="http://schemas.microsoft.com/office/drawing/2014/main" id="{834324BC-1B25-01A0-3B8F-FC61680EA7D7}"/>
              </a:ext>
            </a:extLst>
          </p:cNvPr>
          <p:cNvSpPr txBox="1"/>
          <p:nvPr/>
        </p:nvSpPr>
        <p:spPr>
          <a:xfrm>
            <a:off x="768626" y="4455094"/>
            <a:ext cx="534062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Supplementary Figure 2: Affinity measurement of NbV5 by yeast display.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-C, NbV5 is 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splayed in pYD1-Halo: A) </a:t>
            </a:r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Unlabell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nanobody, B) Control anti-strep nanobody labeled with 4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Halo 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Alexa Fluor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88, C)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bV5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abeled with 4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Halo 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Alexa Fluor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88. D, Apparent KD measurement of NbV5 determined by yeast surface display.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A-C, Data presented are representative of one biological replicates (n=1). D, Data presented are representative of one biological replicates (n=1) in triplicate and represents the mean of % fraction bound. </a:t>
            </a:r>
            <a:endParaRPr lang="fr-F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ZoneTexte 4">
            <a:extLst>
              <a:ext uri="{FF2B5EF4-FFF2-40B4-BE49-F238E27FC236}">
                <a16:creationId xmlns:a16="http://schemas.microsoft.com/office/drawing/2014/main" id="{3ADB1FE1-E594-5CBA-35AA-1B3CCCC5B7D0}"/>
              </a:ext>
            </a:extLst>
          </p:cNvPr>
          <p:cNvSpPr txBox="1"/>
          <p:nvPr/>
        </p:nvSpPr>
        <p:spPr>
          <a:xfrm>
            <a:off x="2570890" y="667258"/>
            <a:ext cx="4511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4" name="ZoneTexte 4">
            <a:extLst>
              <a:ext uri="{FF2B5EF4-FFF2-40B4-BE49-F238E27FC236}">
                <a16:creationId xmlns:a16="http://schemas.microsoft.com/office/drawing/2014/main" id="{948DDF20-B311-3A2F-E6A6-1B72041E48EE}"/>
              </a:ext>
            </a:extLst>
          </p:cNvPr>
          <p:cNvSpPr txBox="1"/>
          <p:nvPr/>
        </p:nvSpPr>
        <p:spPr>
          <a:xfrm>
            <a:off x="4256737" y="667258"/>
            <a:ext cx="4511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54390FF-4B1C-0FCD-C8D3-ACF25BAB9701}"/>
              </a:ext>
            </a:extLst>
          </p:cNvPr>
          <p:cNvSpPr txBox="1"/>
          <p:nvPr/>
        </p:nvSpPr>
        <p:spPr>
          <a:xfrm>
            <a:off x="2813286" y="8383249"/>
            <a:ext cx="1231427" cy="3274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528" dirty="0">
                <a:latin typeface="Arial" panose="020B0604020202020204" pitchFamily="34" charset="0"/>
                <a:cs typeface="Arial" panose="020B0604020202020204" pitchFamily="34" charset="0"/>
              </a:rPr>
              <a:t>Suppl. Fig.2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1A4CBBCF-8C27-4A54-28A6-F1D96106867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00136" y="2615660"/>
            <a:ext cx="2210424" cy="15036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025771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 descr="A screenshot of a computer screen&#10;&#10;Description automatically generated">
            <a:extLst>
              <a:ext uri="{FF2B5EF4-FFF2-40B4-BE49-F238E27FC236}">
                <a16:creationId xmlns:a16="http://schemas.microsoft.com/office/drawing/2014/main" id="{0B950ED6-AF7F-7135-086D-B8C410A4313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3556" y="817949"/>
            <a:ext cx="5450888" cy="456204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766B1778-7E27-EB16-FE2A-F35B0217EA3C}"/>
              </a:ext>
            </a:extLst>
          </p:cNvPr>
          <p:cNvSpPr txBox="1"/>
          <p:nvPr/>
        </p:nvSpPr>
        <p:spPr>
          <a:xfrm>
            <a:off x="2813285" y="8284181"/>
            <a:ext cx="1231427" cy="3274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528" dirty="0">
                <a:latin typeface="Arial" panose="020B0604020202020204" pitchFamily="34" charset="0"/>
                <a:cs typeface="Arial" panose="020B0604020202020204" pitchFamily="34" charset="0"/>
              </a:rPr>
              <a:t>Suppl. Fig.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B9F6A54-9219-08AB-4D64-D4A740550799}"/>
              </a:ext>
            </a:extLst>
          </p:cNvPr>
          <p:cNvSpPr txBox="1"/>
          <p:nvPr/>
        </p:nvSpPr>
        <p:spPr>
          <a:xfrm>
            <a:off x="569022" y="5606525"/>
            <a:ext cx="5765516" cy="26776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200" b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Supplementary Figure 3: Reproducibility of NbV5-based biosensor measurements.</a:t>
            </a:r>
            <a:endParaRPr lang="en-CA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algn="just"/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Biological replicates from Figure 4 (A) and Figure 6 (B) were normalized and presented as % of the best-fitted curve for each experiment to display the inter-reproducibility. Dose-response curves were built using XY analysis for non-linear regression curve and the 3-parameters dose-response stimulation function from GraphPad Prism. Baseline corrected curved were produced using the “Remove baseline and column math” function (Value-Baseline/Baseline). Wells in absence of ligand were used as the baseline for each condition. Data was normalized using the Normalize function from GraphPad Prism, defining the highest Fold-over-baseline condition as the 100% for all data sets and the minimum of the same experiment as the 0% for all data sets. Data are presented as the % of the best responding condition. All error bars represent SD of 3 or 4 technical replicates. Data presented are from a minimum of 3 biological replicates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B2F02A3-3820-5252-590B-1DF1C51C97A2}"/>
              </a:ext>
            </a:extLst>
          </p:cNvPr>
          <p:cNvSpPr txBox="1"/>
          <p:nvPr/>
        </p:nvSpPr>
        <p:spPr>
          <a:xfrm>
            <a:off x="577238" y="630122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B35131A-3E5C-74C8-FE01-5B62B77B37E9}"/>
              </a:ext>
            </a:extLst>
          </p:cNvPr>
          <p:cNvSpPr txBox="1"/>
          <p:nvPr/>
        </p:nvSpPr>
        <p:spPr>
          <a:xfrm>
            <a:off x="577238" y="2336422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77BF1DC4-9BB5-0B99-D607-F85E7025983E}"/>
              </a:ext>
            </a:extLst>
          </p:cNvPr>
          <p:cNvCxnSpPr>
            <a:cxnSpLocks/>
          </p:cNvCxnSpPr>
          <p:nvPr/>
        </p:nvCxnSpPr>
        <p:spPr>
          <a:xfrm>
            <a:off x="783382" y="2382722"/>
            <a:ext cx="5246357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610955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6176A076-F231-3854-21E0-347EED7FA09E}"/>
              </a:ext>
            </a:extLst>
          </p:cNvPr>
          <p:cNvSpPr txBox="1"/>
          <p:nvPr/>
        </p:nvSpPr>
        <p:spPr>
          <a:xfrm>
            <a:off x="2813286" y="8383249"/>
            <a:ext cx="1231427" cy="3274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528" dirty="0">
                <a:latin typeface="Arial" panose="020B0604020202020204" pitchFamily="34" charset="0"/>
                <a:cs typeface="Arial" panose="020B0604020202020204" pitchFamily="34" charset="0"/>
              </a:rPr>
              <a:t>Suppl. Fig.4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898744F-4B73-9562-0E82-584E10D8E430}"/>
              </a:ext>
            </a:extLst>
          </p:cNvPr>
          <p:cNvSpPr txBox="1"/>
          <p:nvPr/>
        </p:nvSpPr>
        <p:spPr>
          <a:xfrm>
            <a:off x="647626" y="4005344"/>
            <a:ext cx="5581320" cy="415498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200" b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Supplementary Figure 4: NbV5 as a versatile nanobody-based biosensor for application in </a:t>
            </a:r>
            <a:r>
              <a:rPr lang="en-CA" sz="1200" b="1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NanoBit</a:t>
            </a:r>
            <a:r>
              <a:rPr lang="en-CA" sz="1200" b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.</a:t>
            </a:r>
            <a:endParaRPr lang="en-CA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algn="just"/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A, By way of comparison, similar results shown with NbV5 were obtained with the nanobody that recognizes the synthetic ALFA-tag (</a:t>
            </a:r>
            <a:r>
              <a:rPr lang="en-US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NbALFA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) at the AT1R-SmBiT. NbV5-based detection of β-arrestin1 and β-arrestin2 recruitment at the AT1R-SmBiT was assayed using N- and C-terminally ALFA-tagged β-arrestin, as well as both N- and C-terminally </a:t>
            </a:r>
            <a:r>
              <a:rPr lang="en-US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LgBiT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-tagged </a:t>
            </a:r>
            <a:r>
              <a:rPr lang="en-US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NbALFA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. B, The selectivity of NbV5 toward the V5-tag over ALFA-tag was confirmed using </a:t>
            </a:r>
            <a:r>
              <a:rPr lang="en-US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NanoBiT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. N- and C-terminally V5- or ALFA-tagged β-arrestin1 recruitment at the AT1R-SmBiT using N- and C-terminally </a:t>
            </a:r>
            <a:r>
              <a:rPr lang="en-US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LgBiT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-tagged NbV5 is shown. C, The multiplexing of the NbV5 with </a:t>
            </a:r>
            <a:r>
              <a:rPr lang="en-US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NbALFA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was tested using </a:t>
            </a:r>
            <a:r>
              <a:rPr lang="en-US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NanoBit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. The C-terminally V5-tagged AT1R (AT1R-V5) was co-transfected with N- or C-terminally </a:t>
            </a:r>
            <a:r>
              <a:rPr lang="en-US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SmBiT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-tagged NbV5, N- or C-terminally ALFA-tagged β -arrestin1 and N- or C-terminally </a:t>
            </a:r>
            <a:r>
              <a:rPr lang="en-US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LgBiT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tagged </a:t>
            </a:r>
            <a:r>
              <a:rPr lang="en-US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NbALFA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. A-C, The receptor was stimulated with a serial dilution of the selective agonist Angiotensin II (</a:t>
            </a:r>
            <a:r>
              <a:rPr lang="en-US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AngII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) and maximum relative light unit (RLU) extracted. Dose-response curves were built using XY analysis for non-linear regression curve and the 3-parameters dose-response stimulation function from GraphPad Prism. Baseline correction was calculated using the “Remove baseline and column math” function (Value-Baseline/Baseline). Wells in absence of ligand were used as the baseline for each condition. All error bars represent SD of 3 or 4 technical replicates. Data presented are representative of 3 biological replicates.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462EAC9A-E1DA-F363-C857-B0395BF14A2E}"/>
              </a:ext>
            </a:extLst>
          </p:cNvPr>
          <p:cNvGrpSpPr/>
          <p:nvPr/>
        </p:nvGrpSpPr>
        <p:grpSpPr>
          <a:xfrm>
            <a:off x="674130" y="983672"/>
            <a:ext cx="5581320" cy="2621138"/>
            <a:chOff x="484318" y="1561710"/>
            <a:chExt cx="5776781" cy="2641600"/>
          </a:xfrm>
        </p:grpSpPr>
        <p:sp>
          <p:nvSpPr>
            <p:cNvPr id="8" name="Google Shape;153;p3">
              <a:extLst>
                <a:ext uri="{FF2B5EF4-FFF2-40B4-BE49-F238E27FC236}">
                  <a16:creationId xmlns:a16="http://schemas.microsoft.com/office/drawing/2014/main" id="{1E83DB31-0731-11E7-4D19-248E889586C2}"/>
                </a:ext>
              </a:extLst>
            </p:cNvPr>
            <p:cNvSpPr txBox="1"/>
            <p:nvPr/>
          </p:nvSpPr>
          <p:spPr>
            <a:xfrm>
              <a:off x="484318" y="1561710"/>
              <a:ext cx="271156" cy="27815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914" tIns="43625" rIns="87275" bIns="43625" anchor="t" anchorCtr="0">
              <a:spAutoFit/>
            </a:bodyPr>
            <a:lstStyle/>
            <a:p>
              <a:r>
                <a:rPr lang="en-CA" sz="1235" b="1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A</a:t>
              </a:r>
              <a:endParaRPr sz="1235" b="1" dirty="0"/>
            </a:p>
          </p:txBody>
        </p:sp>
        <p:sp>
          <p:nvSpPr>
            <p:cNvPr id="9" name="Google Shape;153;p3">
              <a:extLst>
                <a:ext uri="{FF2B5EF4-FFF2-40B4-BE49-F238E27FC236}">
                  <a16:creationId xmlns:a16="http://schemas.microsoft.com/office/drawing/2014/main" id="{E50ADDE9-D585-1766-7AB6-7DA6EC251B7C}"/>
                </a:ext>
              </a:extLst>
            </p:cNvPr>
            <p:cNvSpPr txBox="1"/>
            <p:nvPr/>
          </p:nvSpPr>
          <p:spPr>
            <a:xfrm>
              <a:off x="3539352" y="1561710"/>
              <a:ext cx="271156" cy="27815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914" tIns="43625" rIns="87275" bIns="43625" anchor="t" anchorCtr="0">
              <a:spAutoFit/>
            </a:bodyPr>
            <a:lstStyle/>
            <a:p>
              <a:r>
                <a:rPr lang="en-CA" sz="1235" b="1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B</a:t>
              </a:r>
              <a:endParaRPr sz="1235" b="1" dirty="0"/>
            </a:p>
          </p:txBody>
        </p:sp>
        <p:sp>
          <p:nvSpPr>
            <p:cNvPr id="6" name="Google Shape;153;p3">
              <a:extLst>
                <a:ext uri="{FF2B5EF4-FFF2-40B4-BE49-F238E27FC236}">
                  <a16:creationId xmlns:a16="http://schemas.microsoft.com/office/drawing/2014/main" id="{6872B2EA-49AE-2B98-3A92-9E3BA24290E9}"/>
                </a:ext>
              </a:extLst>
            </p:cNvPr>
            <p:cNvSpPr txBox="1"/>
            <p:nvPr/>
          </p:nvSpPr>
          <p:spPr>
            <a:xfrm>
              <a:off x="484318" y="2811020"/>
              <a:ext cx="271156" cy="27815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914" tIns="43625" rIns="87275" bIns="43625" anchor="t" anchorCtr="0">
              <a:spAutoFit/>
            </a:bodyPr>
            <a:lstStyle/>
            <a:p>
              <a:r>
                <a:rPr lang="en-CA" sz="1235" b="1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</a:t>
              </a:r>
              <a:endParaRPr sz="1235" b="1" dirty="0"/>
            </a:p>
          </p:txBody>
        </p:sp>
        <p:pic>
          <p:nvPicPr>
            <p:cNvPr id="13" name="Picture 12" descr="A picture containing light&#10;&#10;Description automatically generated with medium confidence">
              <a:extLst>
                <a:ext uri="{FF2B5EF4-FFF2-40B4-BE49-F238E27FC236}">
                  <a16:creationId xmlns:a16="http://schemas.microsoft.com/office/drawing/2014/main" id="{A1E40F3E-9DCF-0776-E774-5E86498F871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96899" y="1561710"/>
              <a:ext cx="5664200" cy="26416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9538313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742</TotalTime>
  <Words>875</Words>
  <Application>Microsoft Macintosh PowerPoint</Application>
  <PresentationFormat>Letter Paper (8.5x11 in)</PresentationFormat>
  <Paragraphs>33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trick Giguère</dc:creator>
  <cp:lastModifiedBy>Patrick Giguère</cp:lastModifiedBy>
  <cp:revision>22</cp:revision>
  <dcterms:created xsi:type="dcterms:W3CDTF">2023-04-20T18:01:53Z</dcterms:created>
  <dcterms:modified xsi:type="dcterms:W3CDTF">2023-07-25T19:33:29Z</dcterms:modified>
</cp:coreProperties>
</file>